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1236DA-3530-4638-803E-ECFA278D3F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99DF7-E1C6-4413-B3F9-615BDAA0CD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11B22-C7A1-469E-AE7F-836E225DE08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3282A-25FB-4959-967A-80565839D18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234DC-C4F0-4B6B-92DB-EC8AF090EB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5C520-DBFB-4EDE-8D8B-E92F67AE7C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5457A7-301B-41F4-A19F-BA7264DB8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AFAA8-F36A-4D32-8637-43566DF8A6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894D6-1C3B-4049-BAAC-8E4C584ED9C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DADE4-C6A2-47E8-A4B7-29D8FEFE55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6F6D63-582E-45F0-8FEA-91742A5BF0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D7445-703C-4260-83C7-80B785CE88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AAD5D6-E923-4550-AEE7-FC5628C7FB6F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png"/><Relationship Id="rId7" Type="http://schemas.openxmlformats.org/officeDocument/2006/relationships/oleObject" Target="../embeddings/oleObject4.bin"/><Relationship Id="rId8" Type="http://schemas.openxmlformats.org/officeDocument/2006/relationships/image" Target="../media/image4.png"/><Relationship Id="rId9" Type="http://schemas.openxmlformats.org/officeDocument/2006/relationships/oleObject" Target="../embeddings/oleObject5.bin"/><Relationship Id="rId10" Type="http://schemas.openxmlformats.org/officeDocument/2006/relationships/image" Target="../media/image5.png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6.png"/><Relationship Id="rId1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35240" y="1415880"/>
            <a:ext cx="2160360" cy="1155600"/>
            <a:chOff x="2235240" y="1415880"/>
            <a:chExt cx="2160360" cy="1155600"/>
          </a:xfrm>
        </p:grpSpPr>
        <p:graphicFrame>
          <p:nvGraphicFramePr>
            <p:cNvPr id="42" name=""/>
            <p:cNvGraphicFramePr/>
            <p:nvPr/>
          </p:nvGraphicFramePr>
          <p:xfrm>
            <a:off x="2235240" y="1415880"/>
            <a:ext cx="2158200" cy="34200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2235240" y="1415880"/>
                      <a:ext cx="2158200" cy="3420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2235240" y="1781280"/>
            <a:ext cx="2158200" cy="340560"/>
          </p:xfrm>
          <a:graphic>
            <a:graphicData uri="http://schemas.openxmlformats.org/presentationml/2006/ole">
              <p:oleObj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2235240" y="1781280"/>
                      <a:ext cx="2158200" cy="3405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6" name=""/>
            <p:cNvGraphicFramePr/>
            <p:nvPr/>
          </p:nvGraphicFramePr>
          <p:xfrm>
            <a:off x="2237400" y="2145240"/>
            <a:ext cx="2158200" cy="4262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2237400" y="2145240"/>
                      <a:ext cx="2158200" cy="4262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  <p:sp>
        <p:nvSpPr>
          <p:cNvPr id="48" name=""/>
          <p:cNvSpPr/>
          <p:nvPr/>
        </p:nvSpPr>
        <p:spPr>
          <a:xfrm>
            <a:off x="2239920" y="125424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2171520" y="106380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Col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2345400" y="1100880"/>
            <a:ext cx="560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L</a:t>
            </a:r>
            <a:r>
              <a:rPr b="1" i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er</a:t>
            </a: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r>
              <a:rPr b="1" i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200000">
            <a:off x="2483280" y="1069920"/>
            <a:ext cx="624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iso4e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3009960" y="861840"/>
            <a:ext cx="1225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iso4e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rtm1 backgroun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846520" y="1077840"/>
            <a:ext cx="528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35S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Atiso4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265200" y="1063800"/>
            <a:ext cx="67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35S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Ca4E1 Y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778920" y="1062000"/>
            <a:ext cx="64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35S: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Ca4E1 Fl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919240" y="1073160"/>
            <a:ext cx="1349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2889360" y="1366920"/>
            <a:ext cx="43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357720" y="1378080"/>
            <a:ext cx="43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824280" y="1378080"/>
            <a:ext cx="433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564920" y="140328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wt </a:t>
            </a:r>
            <a:r>
              <a:rPr b="1" i="1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Atiso4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80520" y="1763640"/>
            <a:ext cx="941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Mutant </a:t>
            </a: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ateifiso4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228320" y="2217600"/>
            <a:ext cx="102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rtm1</a:t>
            </a: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 CAPS mark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200000">
            <a:off x="4174920" y="1218240"/>
            <a:ext cx="368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M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322880" y="1627200"/>
            <a:ext cx="690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Arial"/>
              </a:rPr>
              <a:t>250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332240" y="1527120"/>
            <a:ext cx="5047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Arial"/>
              </a:rPr>
              <a:t>500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4335480" y="1420920"/>
            <a:ext cx="4744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Arial"/>
              </a:rPr>
              <a:t>750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330440" y="1325520"/>
            <a:ext cx="4291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600" spc="-1" strike="noStrike">
                <a:solidFill>
                  <a:srgbClr val="000000"/>
                </a:solidFill>
                <a:latin typeface="Times New Roman"/>
                <a:ea typeface="Arial"/>
              </a:rPr>
              <a:t>1000 b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347000" y="2381400"/>
            <a:ext cx="46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250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351680" y="2095560"/>
            <a:ext cx="465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500 b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0" name=""/>
          <p:cNvGraphicFramePr/>
          <p:nvPr/>
        </p:nvGraphicFramePr>
        <p:xfrm>
          <a:off x="3038400" y="3676680"/>
          <a:ext cx="1268640" cy="50004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71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3038400" y="3676680"/>
                    <a:ext cx="1268640" cy="5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2" name=""/>
          <p:cNvGraphicFramePr/>
          <p:nvPr/>
        </p:nvGraphicFramePr>
        <p:xfrm>
          <a:off x="3065400" y="4902120"/>
          <a:ext cx="1273320" cy="5000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73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065400" y="4902120"/>
                    <a:ext cx="1273320" cy="50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74" name=""/>
          <p:cNvGraphicFramePr/>
          <p:nvPr/>
        </p:nvGraphicFramePr>
        <p:xfrm>
          <a:off x="3041640" y="6243480"/>
          <a:ext cx="1273320" cy="49860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75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3041640" y="6243480"/>
                    <a:ext cx="1273320" cy="498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76" name=""/>
          <p:cNvSpPr/>
          <p:nvPr/>
        </p:nvSpPr>
        <p:spPr>
          <a:xfrm rot="16200000">
            <a:off x="3007800" y="331380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l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rot="16200000">
            <a:off x="3169080" y="334548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Ler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rot="16200000">
            <a:off x="3286440" y="3290760"/>
            <a:ext cx="69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594600" y="3141720"/>
            <a:ext cx="775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T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35S:Atiso4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3719520" y="3630600"/>
            <a:ext cx="4316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16200000">
            <a:off x="3012480" y="451872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l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16200000">
            <a:off x="3173760" y="454932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Ler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16200000">
            <a:off x="3287880" y="4502160"/>
            <a:ext cx="69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3666240" y="4386240"/>
            <a:ext cx="9000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T2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35S:Ca4E1 Y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3722760" y="4834080"/>
            <a:ext cx="433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2972880" y="5842800"/>
            <a:ext cx="65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Col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3134160" y="587268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Ler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 rot="16200000">
            <a:off x="3252960" y="5819760"/>
            <a:ext cx="691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658320" y="5778360"/>
            <a:ext cx="968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iso4e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rtm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T2 35:Ca4E1 Fl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700440" y="6156360"/>
            <a:ext cx="432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2152800" y="3787920"/>
            <a:ext cx="1008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Atiso4E 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c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000160" y="4959360"/>
            <a:ext cx="122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Ca4E1 YW 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c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2033640" y="6315120"/>
            <a:ext cx="1152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Ca4E1 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Flo</a:t>
            </a:r>
            <a:r>
              <a:rPr b="1" i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cD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rot="16200000">
            <a:off x="4057200" y="3493080"/>
            <a:ext cx="362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W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413000" y="611280"/>
            <a:ext cx="377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427040" y="278604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260280" y="7236000"/>
            <a:ext cx="576108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Fig. S1: Genotyping of transgenic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</a:rPr>
              <a:t>Arabidopsis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 T2 plants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. For each construct, results from 3 independent T2 are shown. 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A,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Genotyping of the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iso4e rtm1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genetic background of the T2 transgenic plants (see methods).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B,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Genotyping of the inserted T-DNA allowing the overexpression of 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At.eIFiso4E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, Ca.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eIF4E1-pvr2</a:t>
            </a:r>
            <a:r>
              <a:rPr b="0" i="1" lang="en-GB" sz="12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 and Ca.</a:t>
            </a:r>
            <a:r>
              <a:rPr b="0" i="1" lang="en-GB" sz="1200" spc="-1" strike="noStrike">
                <a:solidFill>
                  <a:srgbClr val="000000"/>
                </a:solidFill>
                <a:latin typeface="Arial"/>
              </a:rPr>
              <a:t>eIF4E1-pvr2</a:t>
            </a:r>
            <a:r>
              <a:rPr b="0" i="1" lang="en-GB" sz="1200" spc="-1" strike="noStrike" baseline="30000">
                <a:solidFill>
                  <a:srgbClr val="000000"/>
                </a:solidFill>
                <a:latin typeface="Arial"/>
              </a:rPr>
              <a:t>2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, respectively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024000" y="348768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3071880" y="471816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3028680" y="6024600"/>
            <a:ext cx="214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  <a:ea typeface="Arial"/>
              </a:rPr>
              <a:t>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2T08:46:39Z</dcterms:created>
  <dc:creator>jlgallois</dc:creator>
  <dc:description/>
  <dc:language>en-US</dc:language>
  <cp:lastModifiedBy>jlgallois</cp:lastModifiedBy>
  <dcterms:modified xsi:type="dcterms:W3CDTF">2014-01-16T20:34:46Z</dcterms:modified>
  <cp:revision>5</cp:revision>
  <dc:subject/>
  <dc:title>Diapositive 1</dc:title>
</cp:coreProperties>
</file>